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552" r:id="rId2"/>
    <p:sldId id="55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9AD6BA-A0BE-4645-939B-9B41B874DE09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4E80FC-0622-4A3E-A5F9-B51CB10874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9128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Overexpression of YTHDF1-FLAG signi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+fb"/>
              </a:rPr>
              <a:t>fi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cantly increased</a:t>
            </a:r>
          </a:p>
          <a:p>
            <a:pPr algn="l"/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the protein expression of JAK2 in </a:t>
            </a:r>
            <a:r>
              <a:rPr lang="en-US" sz="1800" b="0" i="0" u="none" strike="noStrike" baseline="0" dirty="0" err="1">
                <a:solidFill>
                  <a:srgbClr val="000000"/>
                </a:solidFill>
                <a:latin typeface="AdvOTa9103878"/>
              </a:rPr>
              <a:t>piPSCs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 (Fig. </a:t>
            </a:r>
            <a:r>
              <a:rPr lang="en-US" sz="1800" b="0" i="0" u="none" strike="noStrike" baseline="0" dirty="0">
                <a:solidFill>
                  <a:srgbClr val="0000FF"/>
                </a:solidFill>
                <a:latin typeface="AdvOTa9103878"/>
              </a:rPr>
              <a:t>5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a), con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+fb"/>
              </a:rPr>
              <a:t>fi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rming</a:t>
            </a:r>
          </a:p>
          <a:p>
            <a:pPr algn="l"/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that YTHDF1 is involved in regulation of JAK2.</a:t>
            </a:r>
          </a:p>
          <a:p>
            <a:pPr algn="l"/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As expected, RIP-qPCR analysis revealed that JAK2 is a</a:t>
            </a:r>
          </a:p>
          <a:p>
            <a:pPr algn="l"/>
            <a:r>
              <a:rPr lang="en-US" sz="1800" b="0" i="0" u="none" strike="noStrike" baseline="0" dirty="0">
                <a:solidFill>
                  <a:srgbClr val="000000"/>
                </a:solidFill>
                <a:latin typeface="AdvOTa9103878"/>
              </a:rPr>
              <a:t>target gene of YTHDF1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F5915C-CD2D-4D0D-8004-C3F28A9352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76603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sz="1800" b="0" i="0" u="none" strike="noStrike" baseline="0" dirty="0">
                <a:latin typeface="AdvOTce3d9a73"/>
              </a:rPr>
              <a:t>b </a:t>
            </a:r>
            <a:r>
              <a:rPr lang="en-US" sz="1800" b="0" i="0" u="none" strike="noStrike" baseline="0" dirty="0">
                <a:latin typeface="AdvOT07517017"/>
              </a:rPr>
              <a:t>RIP analysis of the interaction of JAK2 with FLAG in </a:t>
            </a:r>
            <a:r>
              <a:rPr lang="en-US" sz="1800" b="0" i="0" u="none" strike="noStrike" baseline="0" dirty="0" err="1">
                <a:latin typeface="AdvOT07517017"/>
              </a:rPr>
              <a:t>piPSCs</a:t>
            </a:r>
            <a:endParaRPr lang="en-US" sz="1800" b="0" i="0" u="none" strike="noStrike" baseline="0" dirty="0">
              <a:latin typeface="AdvOT07517017"/>
            </a:endParaRPr>
          </a:p>
          <a:p>
            <a:pPr algn="l"/>
            <a:r>
              <a:rPr lang="en-US" sz="1800" b="0" i="0" u="none" strike="noStrike" baseline="0" dirty="0">
                <a:latin typeface="AdvOT07517017"/>
              </a:rPr>
              <a:t>transfected with YTHDF2-FLAG plasmid. Enrichment of JAK2 with FLAG was measured by qPCR and normalized to input. </a:t>
            </a:r>
            <a:r>
              <a:rPr lang="en-US" sz="1800" b="0" i="0" u="none" strike="noStrike" baseline="0" dirty="0">
                <a:latin typeface="AdvOTce3d9a73"/>
              </a:rPr>
              <a:t>c </a:t>
            </a:r>
            <a:r>
              <a:rPr lang="en-US" sz="1800" b="0" i="0" u="none" strike="noStrike" baseline="0" dirty="0">
                <a:latin typeface="AdvOT07517017"/>
              </a:rPr>
              <a:t>Relative luciferase activity</a:t>
            </a:r>
          </a:p>
          <a:p>
            <a:pPr algn="l"/>
            <a:r>
              <a:rPr lang="en-US" sz="1800" b="0" i="0" u="none" strike="noStrike" baseline="0" dirty="0">
                <a:latin typeface="AdvOT07517017"/>
              </a:rPr>
              <a:t>of WT or MUT JAK2-3</a:t>
            </a:r>
            <a:r>
              <a:rPr lang="en-US" sz="1800" b="0" i="0" u="none" strike="noStrike" baseline="0" dirty="0">
                <a:latin typeface="AdvTTab7e17fd+20"/>
              </a:rPr>
              <a:t>′</a:t>
            </a:r>
            <a:r>
              <a:rPr lang="en-US" sz="1800" b="0" i="0" u="none" strike="noStrike" baseline="0" dirty="0">
                <a:latin typeface="AdvOT07517017"/>
              </a:rPr>
              <a:t>UTR luciferase reporter in </a:t>
            </a:r>
            <a:r>
              <a:rPr lang="en-US" sz="1800" b="0" i="0" u="none" strike="noStrike" baseline="0" dirty="0" err="1">
                <a:latin typeface="AdvOT07517017"/>
              </a:rPr>
              <a:t>piPSCs</a:t>
            </a:r>
            <a:r>
              <a:rPr lang="en-US" sz="1800" b="0" i="0" u="none" strike="noStrike" baseline="0" dirty="0">
                <a:latin typeface="AdvOT07517017"/>
              </a:rPr>
              <a:t> transfected with control or YTHDF2 plasmid. Fire</a:t>
            </a:r>
            <a:r>
              <a:rPr lang="en-US" sz="1800" b="0" i="0" u="none" strike="noStrike" baseline="0" dirty="0">
                <a:latin typeface="AdvOT07517017+fb"/>
              </a:rPr>
              <a:t>fl</a:t>
            </a:r>
            <a:r>
              <a:rPr lang="en-US" sz="1800" b="0" i="0" u="none" strike="noStrike" baseline="0" dirty="0">
                <a:latin typeface="AdvOT07517017"/>
              </a:rPr>
              <a:t>y luciferase activity was measured and</a:t>
            </a:r>
          </a:p>
          <a:p>
            <a:pPr algn="l"/>
            <a:r>
              <a:rPr lang="en-US" sz="1800" b="0" i="0" u="none" strike="noStrike" baseline="0" dirty="0">
                <a:latin typeface="AdvOT07517017"/>
              </a:rPr>
              <a:t>normalized to </a:t>
            </a:r>
            <a:r>
              <a:rPr lang="en-US" sz="1800" b="0" i="0" u="none" strike="noStrike" baseline="0" dirty="0" err="1">
                <a:latin typeface="AdvOT07517017"/>
              </a:rPr>
              <a:t>Renilla</a:t>
            </a:r>
            <a:r>
              <a:rPr lang="en-US" sz="1800" b="0" i="0" u="none" strike="noStrike" baseline="0" dirty="0">
                <a:latin typeface="AdvOT07517017"/>
              </a:rPr>
              <a:t> luciferase activity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F5915C-CD2D-4D0D-8004-C3F28A93520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9710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8FCE2C-5135-F518-C677-CB34028B88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754602-E612-8AEF-331E-33D02D1882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BDA752-C5CE-6BB2-D05C-AFED87EA1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C619AE-41FA-DBC1-BFEA-EFC54E086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2E09D0-7989-591C-79DC-7D888B58F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46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66E42-AE8C-6DB3-ED39-0AD917EBD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FA89B1-DDE2-38E5-B8F0-3F6E1D9652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D4F1DA-1932-B96C-8F9F-554FA03CD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0473DC-70DD-576A-A653-E060A1477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D6853-C99B-D90C-9ACA-946CEDD14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696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06BB45-9C3B-97A6-FBC1-66A6B1141C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659F51-F6BE-54A1-73DA-3E5DF2FA8F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130D14-0CF7-CFA7-752B-F5FC0B089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655CA8-E240-C3B8-FBCF-0535F3B22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83C646-6F92-4AA3-098F-153696DAA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791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F78365-E083-E6FB-EF7E-DA5C7B6C78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5FA8B6-B412-C8DE-C650-DB32933862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276C4-5F5A-38D1-A6DD-3BC0092A0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F2C91-E57A-BF16-E168-CD8658BCC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3050BD-7834-A790-820A-ADFDB9127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20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2DE4B-9BCA-D1B6-C9BC-C51E4F453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471803-46A9-C4FA-65B7-4BDFD83D73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C4F75-9AA6-A042-EA39-AD3D8A167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48E0EB-ED8F-7789-2ADA-7BF4B84B7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2020D-52A1-9C64-DF06-F752F51B6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851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9BDFE-F320-1D2C-5D2A-C9A20EFE83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CB31CD-91A6-48C1-C822-A3038309BE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8DA772-26AC-5472-4495-5565B898BC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36D748-432E-ED03-A181-15FA5AC9F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A25F29-6986-0DA1-C444-A0D7F7F2C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C2E168-41E8-55BA-200B-37473DDD1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890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73896A-6738-DBAF-51DD-89A367C87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4F526F-489D-447F-E3DD-ABC088EC6C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419B4B-9EAC-95AE-61C3-E4D8A7296F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9EB564-FCC8-A1C3-D8B7-4FB9775B1A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6AD7A0-EAC7-72FB-6FF4-2E7DF917D6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E18A31-B56B-0A65-7074-07F12E8FA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EDDB80-551D-CF11-D3FE-EC68E987B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7806B1-F457-2ACC-E581-DE1A5201E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846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0B2DB2-15EA-E8BD-A7F0-A9BE153C0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B24393-11C8-3117-26E8-CB278BC42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A3D83E-9D1C-D2EE-76AF-E995648C7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9091D25-E051-CFD9-1961-C1DF0E1F6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577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EAD816-69C3-BABA-7679-5412D6F91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F7C6A6-291B-5EEF-59AA-CACD47649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C8A18F-2533-9ADF-7BCB-387068184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733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C7CD4-215E-A93F-5264-2D949A60B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280097-A05C-4F33-9163-274E3D80E0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99272C-BF52-801F-3637-112C277F64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E2CDD8-7FFF-BF9D-A8E0-DEFBE98DB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B0BB2-E13F-71A7-9F5B-59F20DA2A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1757CB-F448-BD54-04E3-6A1D32899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08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3044E-179D-C9E8-7505-CBABC30F7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73212B-8B52-B2F0-5310-E8A9661C53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86E4AC-60EC-F13C-B87B-BC8695D5BC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0E8037-F19D-931F-D69E-7B883185F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922019-8F3F-BE8D-EFDC-4EE2138FF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A22D05-25C1-0F17-7902-5671AAA7B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955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0CBD9E-EE46-AC91-DAE7-485C57F05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88B0DE-5473-ABB4-0CFD-5895FF688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53E476-1329-C68D-B7DA-4C3B09493E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4EA17D-C5D5-40A8-981B-EC5253EBF1E5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7749D1-ECD9-E6FD-B249-006C963DB4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2CF97B-3408-5A35-FD7D-D07FF9A0A5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5A5F2-53DB-40C7-B385-3A6B8E546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925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Tif"/><Relationship Id="rId7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"/><Relationship Id="rId5" Type="http://schemas.openxmlformats.org/officeDocument/2006/relationships/image" Target="../media/image6.Ti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68">
            <a:extLst>
              <a:ext uri="{FF2B5EF4-FFF2-40B4-BE49-F238E27FC236}">
                <a16:creationId xmlns:a16="http://schemas.microsoft.com/office/drawing/2014/main" id="{D037A9BC-63C3-4D9D-9059-3510AF592F56}"/>
              </a:ext>
            </a:extLst>
          </p:cNvPr>
          <p:cNvSpPr txBox="1"/>
          <p:nvPr/>
        </p:nvSpPr>
        <p:spPr>
          <a:xfrm>
            <a:off x="5631168" y="2142767"/>
            <a:ext cx="1822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YTHDF1</a:t>
            </a:r>
          </a:p>
        </p:txBody>
      </p:sp>
      <p:sp>
        <p:nvSpPr>
          <p:cNvPr id="13" name="文本框 5">
            <a:extLst>
              <a:ext uri="{FF2B5EF4-FFF2-40B4-BE49-F238E27FC236}">
                <a16:creationId xmlns:a16="http://schemas.microsoft.com/office/drawing/2014/main" id="{88B3EFD1-CF29-4D83-9712-81BB04670C06}"/>
              </a:ext>
            </a:extLst>
          </p:cNvPr>
          <p:cNvSpPr txBox="1"/>
          <p:nvPr/>
        </p:nvSpPr>
        <p:spPr>
          <a:xfrm>
            <a:off x="5589423" y="2708804"/>
            <a:ext cx="12795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4" name="文本框 68">
            <a:extLst>
              <a:ext uri="{FF2B5EF4-FFF2-40B4-BE49-F238E27FC236}">
                <a16:creationId xmlns:a16="http://schemas.microsoft.com/office/drawing/2014/main" id="{51D17145-E0F3-4288-978D-016DCA3B296F}"/>
              </a:ext>
            </a:extLst>
          </p:cNvPr>
          <p:cNvSpPr txBox="1"/>
          <p:nvPr/>
        </p:nvSpPr>
        <p:spPr>
          <a:xfrm>
            <a:off x="5716367" y="1635356"/>
            <a:ext cx="11632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TLR2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141EDF0-6FE8-47DA-A894-F72F7FFADFB9}"/>
              </a:ext>
            </a:extLst>
          </p:cNvPr>
          <p:cNvSpPr txBox="1"/>
          <p:nvPr/>
        </p:nvSpPr>
        <p:spPr>
          <a:xfrm rot="18924692">
            <a:off x="4833833" y="132337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4DE7520-1A96-4BA1-B9C8-D5F10BD60AE7}"/>
              </a:ext>
            </a:extLst>
          </p:cNvPr>
          <p:cNvSpPr txBox="1"/>
          <p:nvPr/>
        </p:nvSpPr>
        <p:spPr>
          <a:xfrm rot="18924692">
            <a:off x="3931872" y="216169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E83206B-2B55-48CB-B0CE-671B7D6D76B0}"/>
              </a:ext>
            </a:extLst>
          </p:cNvPr>
          <p:cNvSpPr txBox="1"/>
          <p:nvPr/>
        </p:nvSpPr>
        <p:spPr>
          <a:xfrm>
            <a:off x="3095839" y="1552897"/>
            <a:ext cx="8150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3084ADF-A42A-48FC-9311-35B5994B56C1}"/>
              </a:ext>
            </a:extLst>
          </p:cNvPr>
          <p:cNvSpPr txBox="1"/>
          <p:nvPr/>
        </p:nvSpPr>
        <p:spPr>
          <a:xfrm>
            <a:off x="3248239" y="2118935"/>
            <a:ext cx="6626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2D49A24-56B8-4B14-AD16-BEF8236882AC}"/>
              </a:ext>
            </a:extLst>
          </p:cNvPr>
          <p:cNvSpPr txBox="1"/>
          <p:nvPr/>
        </p:nvSpPr>
        <p:spPr>
          <a:xfrm>
            <a:off x="3248239" y="2754542"/>
            <a:ext cx="6626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1" name="文本框 5">
            <a:extLst>
              <a:ext uri="{FF2B5EF4-FFF2-40B4-BE49-F238E27FC236}">
                <a16:creationId xmlns:a16="http://schemas.microsoft.com/office/drawing/2014/main" id="{DE122CA3-BEDB-627A-D6A5-B89ECABC66DA}"/>
              </a:ext>
            </a:extLst>
          </p:cNvPr>
          <p:cNvSpPr txBox="1"/>
          <p:nvPr/>
        </p:nvSpPr>
        <p:spPr>
          <a:xfrm>
            <a:off x="221438" y="-224060"/>
            <a:ext cx="9380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aDu</a:t>
            </a:r>
            <a:endParaRPr kumimoji="1"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98D45370-C198-5D8F-D1B9-C75A6AA248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86" t="53445" r="35544" b="41887"/>
          <a:stretch/>
        </p:blipFill>
        <p:spPr>
          <a:xfrm>
            <a:off x="-5486400" y="2113982"/>
            <a:ext cx="11075823" cy="4965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A picture containing text&#10;&#10;Description automatically generated">
            <a:extLst>
              <a:ext uri="{FF2B5EF4-FFF2-40B4-BE49-F238E27FC236}">
                <a16:creationId xmlns:a16="http://schemas.microsoft.com/office/drawing/2014/main" id="{D1CCBA1D-3E72-9D87-9C0F-8EB8B0280D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847" t="52689" r="27844" b="42298"/>
          <a:stretch/>
        </p:blipFill>
        <p:spPr>
          <a:xfrm>
            <a:off x="-3167406" y="1171820"/>
            <a:ext cx="8767043" cy="8512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 descr="A picture containing text&#10;&#10;Description automatically generated">
            <a:extLst>
              <a:ext uri="{FF2B5EF4-FFF2-40B4-BE49-F238E27FC236}">
                <a16:creationId xmlns:a16="http://schemas.microsoft.com/office/drawing/2014/main" id="{F739D27F-6DAB-AB11-5BDC-11525CD2CFF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07" t="31327" r="25000" b="57149"/>
          <a:stretch/>
        </p:blipFill>
        <p:spPr>
          <a:xfrm>
            <a:off x="-2393004" y="2691755"/>
            <a:ext cx="13618723" cy="1076742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14DF6090-75B1-1E05-33F6-91CF10575B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1238021"/>
              </p:ext>
            </p:extLst>
          </p:nvPr>
        </p:nvGraphicFramePr>
        <p:xfrm>
          <a:off x="487915" y="5148311"/>
          <a:ext cx="2749550" cy="3678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748971" imgH="3678448" progId="Prism9.Document">
                  <p:embed/>
                </p:oleObj>
              </mc:Choice>
              <mc:Fallback>
                <p:oleObj name="Prism 9" r:id="rId7" imgW="2748971" imgH="3678448" progId="Prism9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14DF6090-75B1-1E05-33F6-91CF10575B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87915" y="5148311"/>
                        <a:ext cx="2749550" cy="3678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04E1AEA-D9C1-6E81-877E-A7DD1FBD10B1}"/>
              </a:ext>
            </a:extLst>
          </p:cNvPr>
          <p:cNvSpPr txBox="1"/>
          <p:nvPr/>
        </p:nvSpPr>
        <p:spPr>
          <a:xfrm rot="18924692">
            <a:off x="6535450" y="3414714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44E030-7E14-E24D-D47A-FCB6D8CA1954}"/>
              </a:ext>
            </a:extLst>
          </p:cNvPr>
          <p:cNvSpPr txBox="1"/>
          <p:nvPr/>
        </p:nvSpPr>
        <p:spPr>
          <a:xfrm rot="18924692">
            <a:off x="5633489" y="3498546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C39E7FE-E599-253F-13D9-B9EF71384779}"/>
              </a:ext>
            </a:extLst>
          </p:cNvPr>
          <p:cNvSpPr txBox="1"/>
          <p:nvPr/>
        </p:nvSpPr>
        <p:spPr>
          <a:xfrm rot="18924692">
            <a:off x="9104337" y="3321993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F7CC46-89D3-FEA4-C809-0A6027DFEB59}"/>
              </a:ext>
            </a:extLst>
          </p:cNvPr>
          <p:cNvSpPr txBox="1"/>
          <p:nvPr/>
        </p:nvSpPr>
        <p:spPr>
          <a:xfrm rot="18924692">
            <a:off x="8202376" y="3405825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A86208-7360-B1FD-3826-D8B2FEC1DF41}"/>
              </a:ext>
            </a:extLst>
          </p:cNvPr>
          <p:cNvSpPr txBox="1"/>
          <p:nvPr/>
        </p:nvSpPr>
        <p:spPr>
          <a:xfrm rot="18924692">
            <a:off x="4067122" y="3535137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E1E2DE-674A-97B9-46B6-3D321E2BCAFB}"/>
              </a:ext>
            </a:extLst>
          </p:cNvPr>
          <p:cNvSpPr txBox="1"/>
          <p:nvPr/>
        </p:nvSpPr>
        <p:spPr>
          <a:xfrm rot="18924692">
            <a:off x="3165161" y="3618969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CC80C41-68B0-53A0-C9C9-0711BE7C44A3}"/>
              </a:ext>
            </a:extLst>
          </p:cNvPr>
          <p:cNvSpPr txBox="1"/>
          <p:nvPr/>
        </p:nvSpPr>
        <p:spPr>
          <a:xfrm rot="18924692">
            <a:off x="1434586" y="3597361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676126-D743-946A-7B92-6B90EE21FB80}"/>
              </a:ext>
            </a:extLst>
          </p:cNvPr>
          <p:cNvSpPr txBox="1"/>
          <p:nvPr/>
        </p:nvSpPr>
        <p:spPr>
          <a:xfrm rot="18924692">
            <a:off x="532625" y="3681193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BCD6EAF-8907-D4C8-AE07-BB8CD27C8C98}"/>
              </a:ext>
            </a:extLst>
          </p:cNvPr>
          <p:cNvSpPr txBox="1"/>
          <p:nvPr/>
        </p:nvSpPr>
        <p:spPr>
          <a:xfrm rot="18924692">
            <a:off x="-1250415" y="3693097"/>
            <a:ext cx="2200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YTHDF1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A22C1EA-B71C-A952-57F9-8EE234C4FB6F}"/>
              </a:ext>
            </a:extLst>
          </p:cNvPr>
          <p:cNvSpPr txBox="1"/>
          <p:nvPr/>
        </p:nvSpPr>
        <p:spPr>
          <a:xfrm rot="18924692">
            <a:off x="-2152376" y="3776929"/>
            <a:ext cx="1746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68">
            <a:extLst>
              <a:ext uri="{FF2B5EF4-FFF2-40B4-BE49-F238E27FC236}">
                <a16:creationId xmlns:a16="http://schemas.microsoft.com/office/drawing/2014/main" id="{84102184-7E12-843F-41B8-855847882E7F}"/>
              </a:ext>
            </a:extLst>
          </p:cNvPr>
          <p:cNvSpPr txBox="1"/>
          <p:nvPr/>
        </p:nvSpPr>
        <p:spPr>
          <a:xfrm>
            <a:off x="10709017" y="2708804"/>
            <a:ext cx="1822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B15C0EA-BDA3-1B14-6CD6-54CDBF438589}"/>
              </a:ext>
            </a:extLst>
          </p:cNvPr>
          <p:cNvSpPr txBox="1"/>
          <p:nvPr/>
        </p:nvSpPr>
        <p:spPr>
          <a:xfrm>
            <a:off x="221438" y="360189"/>
            <a:ext cx="90126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2022-11-19</a:t>
            </a:r>
          </a:p>
        </p:txBody>
      </p:sp>
    </p:spTree>
    <p:extLst>
      <p:ext uri="{BB962C8B-B14F-4D97-AF65-F5344CB8AC3E}">
        <p14:creationId xmlns:p14="http://schemas.microsoft.com/office/powerpoint/2010/main" val="3489533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2D1ABCF-4FB1-3E68-6D3E-1122428A8F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3793020"/>
              </p:ext>
            </p:extLst>
          </p:nvPr>
        </p:nvGraphicFramePr>
        <p:xfrm>
          <a:off x="0" y="1189490"/>
          <a:ext cx="3468687" cy="3706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468160" imgH="3707605" progId="Prism9.Document">
                  <p:embed/>
                </p:oleObj>
              </mc:Choice>
              <mc:Fallback>
                <p:oleObj name="Prism 9" r:id="rId3" imgW="3468160" imgH="3707605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2D1ABCF-4FB1-3E68-6D3E-1122428A8F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189490"/>
                        <a:ext cx="3468687" cy="3706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Picture 17" descr="A picture containing text&#10;&#10;Description automatically generated">
            <a:extLst>
              <a:ext uri="{FF2B5EF4-FFF2-40B4-BE49-F238E27FC236}">
                <a16:creationId xmlns:a16="http://schemas.microsoft.com/office/drawing/2014/main" id="{BB060EB3-D778-C921-EB23-8D239EC1327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25" t="24499" r="49822" b="67902"/>
          <a:stretch/>
        </p:blipFill>
        <p:spPr>
          <a:xfrm flipH="1">
            <a:off x="8443607" y="3795664"/>
            <a:ext cx="1959275" cy="912523"/>
          </a:xfrm>
          <a:custGeom>
            <a:avLst/>
            <a:gdLst>
              <a:gd name="connsiteX0" fmla="*/ 0 w 679392"/>
              <a:gd name="connsiteY0" fmla="*/ 0 h 267775"/>
              <a:gd name="connsiteX1" fmla="*/ 679392 w 679392"/>
              <a:gd name="connsiteY1" fmla="*/ 0 h 267775"/>
              <a:gd name="connsiteX2" fmla="*/ 679392 w 679392"/>
              <a:gd name="connsiteY2" fmla="*/ 267775 h 267775"/>
              <a:gd name="connsiteX3" fmla="*/ 0 w 679392"/>
              <a:gd name="connsiteY3" fmla="*/ 267775 h 2677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79392" h="267775">
                <a:moveTo>
                  <a:pt x="0" y="0"/>
                </a:moveTo>
                <a:lnTo>
                  <a:pt x="679392" y="0"/>
                </a:lnTo>
                <a:lnTo>
                  <a:pt x="679392" y="267775"/>
                </a:lnTo>
                <a:lnTo>
                  <a:pt x="0" y="267775"/>
                </a:lnTo>
                <a:close/>
              </a:path>
            </a:pathLst>
          </a:custGeom>
          <a:ln>
            <a:noFill/>
          </a:ln>
        </p:spPr>
      </p:pic>
      <p:pic>
        <p:nvPicPr>
          <p:cNvPr id="4" name="Picture 3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7785AEFD-64F1-9942-C99E-7653D1DB8AE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67" t="25396" r="62420" b="61774"/>
          <a:stretch/>
        </p:blipFill>
        <p:spPr>
          <a:xfrm rot="21292154" flipH="1">
            <a:off x="8534718" y="2626850"/>
            <a:ext cx="1953255" cy="1540823"/>
          </a:xfrm>
          <a:custGeom>
            <a:avLst/>
            <a:gdLst>
              <a:gd name="connsiteX0" fmla="*/ 7120659 w 7179791"/>
              <a:gd name="connsiteY0" fmla="*/ 0 h 1297927"/>
              <a:gd name="connsiteX1" fmla="*/ 0 w 7179791"/>
              <a:gd name="connsiteY1" fmla="*/ 639356 h 1297927"/>
              <a:gd name="connsiteX2" fmla="*/ 59132 w 7179791"/>
              <a:gd name="connsiteY2" fmla="*/ 1297927 h 1297927"/>
              <a:gd name="connsiteX3" fmla="*/ 7179791 w 7179791"/>
              <a:gd name="connsiteY3" fmla="*/ 658571 h 129792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179791" h="1297927">
                <a:moveTo>
                  <a:pt x="7120659" y="0"/>
                </a:moveTo>
                <a:lnTo>
                  <a:pt x="0" y="639356"/>
                </a:lnTo>
                <a:lnTo>
                  <a:pt x="59132" y="1297927"/>
                </a:lnTo>
                <a:lnTo>
                  <a:pt x="7179791" y="658571"/>
                </a:lnTo>
                <a:close/>
              </a:path>
            </a:pathLst>
          </a:custGeom>
          <a:ln>
            <a:noFill/>
          </a:ln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95B01BFD-DFB7-04E1-4A07-E138BAD3CA43}"/>
              </a:ext>
            </a:extLst>
          </p:cNvPr>
          <p:cNvGrpSpPr/>
          <p:nvPr/>
        </p:nvGrpSpPr>
        <p:grpSpPr>
          <a:xfrm>
            <a:off x="10735648" y="3329472"/>
            <a:ext cx="1718595" cy="1354440"/>
            <a:chOff x="13467526" y="2671669"/>
            <a:chExt cx="1718595" cy="1354440"/>
          </a:xfrm>
        </p:grpSpPr>
        <p:sp>
          <p:nvSpPr>
            <p:cNvPr id="32" name="文本框 68">
              <a:extLst>
                <a:ext uri="{FF2B5EF4-FFF2-40B4-BE49-F238E27FC236}">
                  <a16:creationId xmlns:a16="http://schemas.microsoft.com/office/drawing/2014/main" id="{8CD24BA3-69F5-C7F9-9D1C-BD2FA919DE00}"/>
                </a:ext>
              </a:extLst>
            </p:cNvPr>
            <p:cNvSpPr txBox="1"/>
            <p:nvPr/>
          </p:nvSpPr>
          <p:spPr>
            <a:xfrm>
              <a:off x="13467526" y="2671669"/>
              <a:ext cx="1654274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YTHDF1</a:t>
              </a:r>
            </a:p>
          </p:txBody>
        </p:sp>
        <p:sp>
          <p:nvSpPr>
            <p:cNvPr id="33" name="文本框 68">
              <a:extLst>
                <a:ext uri="{FF2B5EF4-FFF2-40B4-BE49-F238E27FC236}">
                  <a16:creationId xmlns:a16="http://schemas.microsoft.com/office/drawing/2014/main" id="{6E6BDA33-0EEC-8AEF-ADAA-7C903C7A1CA7}"/>
                </a:ext>
              </a:extLst>
            </p:cNvPr>
            <p:cNvSpPr txBox="1"/>
            <p:nvPr/>
          </p:nvSpPr>
          <p:spPr>
            <a:xfrm>
              <a:off x="13531847" y="3564444"/>
              <a:ext cx="1654274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34" name="文本框 68">
            <a:extLst>
              <a:ext uri="{FF2B5EF4-FFF2-40B4-BE49-F238E27FC236}">
                <a16:creationId xmlns:a16="http://schemas.microsoft.com/office/drawing/2014/main" id="{A80084B9-6F3F-E947-5FB1-3B9083A2CD1A}"/>
              </a:ext>
            </a:extLst>
          </p:cNvPr>
          <p:cNvSpPr txBox="1"/>
          <p:nvPr/>
        </p:nvSpPr>
        <p:spPr>
          <a:xfrm>
            <a:off x="7839563" y="3902040"/>
            <a:ext cx="165427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5" name="文本框 68">
            <a:extLst>
              <a:ext uri="{FF2B5EF4-FFF2-40B4-BE49-F238E27FC236}">
                <a16:creationId xmlns:a16="http://schemas.microsoft.com/office/drawing/2014/main" id="{16879B68-50C1-906C-3865-EF32865DBD06}"/>
              </a:ext>
            </a:extLst>
          </p:cNvPr>
          <p:cNvSpPr txBox="1"/>
          <p:nvPr/>
        </p:nvSpPr>
        <p:spPr>
          <a:xfrm>
            <a:off x="7778504" y="3207672"/>
            <a:ext cx="165427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36" name="文本框 68">
            <a:extLst>
              <a:ext uri="{FF2B5EF4-FFF2-40B4-BE49-F238E27FC236}">
                <a16:creationId xmlns:a16="http://schemas.microsoft.com/office/drawing/2014/main" id="{2BA07B62-F369-386D-EE4C-2E8AD98E123D}"/>
              </a:ext>
            </a:extLst>
          </p:cNvPr>
          <p:cNvSpPr txBox="1"/>
          <p:nvPr/>
        </p:nvSpPr>
        <p:spPr>
          <a:xfrm>
            <a:off x="3721480" y="958073"/>
            <a:ext cx="165427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dirty="0" err="1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kDa</a:t>
            </a:r>
            <a:endParaRPr lang="en-US" altLang="zh-CN" sz="2400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D06940-41EC-439C-12E0-5CC7F6FF489F}"/>
              </a:ext>
            </a:extLst>
          </p:cNvPr>
          <p:cNvSpPr txBox="1"/>
          <p:nvPr/>
        </p:nvSpPr>
        <p:spPr>
          <a:xfrm rot="18924692">
            <a:off x="9172288" y="1931065"/>
            <a:ext cx="2200399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YTHDF1-OE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81AF6C-3EE3-ED88-E7C8-E1673C4D6664}"/>
              </a:ext>
            </a:extLst>
          </p:cNvPr>
          <p:cNvSpPr txBox="1"/>
          <p:nvPr/>
        </p:nvSpPr>
        <p:spPr>
          <a:xfrm rot="18924692">
            <a:off x="8579774" y="2147998"/>
            <a:ext cx="1746914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ector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3683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36</Words>
  <Application>Microsoft Office PowerPoint</Application>
  <PresentationFormat>Widescreen</PresentationFormat>
  <Paragraphs>39</Paragraphs>
  <Slides>2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3" baseType="lpstr">
      <vt:lpstr>AdvOT07517017</vt:lpstr>
      <vt:lpstr>AdvOT07517017+fb</vt:lpstr>
      <vt:lpstr>AdvOTa9103878</vt:lpstr>
      <vt:lpstr>AdvOTa9103878+fb</vt:lpstr>
      <vt:lpstr>AdvOTce3d9a73</vt:lpstr>
      <vt:lpstr>AdvTTab7e17fd+20</vt:lpstr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 ye</dc:creator>
  <cp:lastModifiedBy>jing ye</cp:lastModifiedBy>
  <cp:revision>2</cp:revision>
  <dcterms:created xsi:type="dcterms:W3CDTF">2023-04-07T08:57:21Z</dcterms:created>
  <dcterms:modified xsi:type="dcterms:W3CDTF">2023-04-07T09:22:48Z</dcterms:modified>
</cp:coreProperties>
</file>